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890"/>
    <p:restoredTop sz="94694"/>
  </p:normalViewPr>
  <p:slideViewPr>
    <p:cSldViewPr snapToGrid="0" snapToObjects="1">
      <p:cViewPr>
        <p:scale>
          <a:sx n="164" d="100"/>
          <a:sy n="164" d="100"/>
        </p:scale>
        <p:origin x="-856" y="-7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31A77A-BC87-D84C-9E86-830E0A6D287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1484FC9-32ED-D140-9D18-0315F6A891D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3F600D3-0333-B045-AE74-ABC1B83353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FF8DB-CD13-B140-B6B9-7CACDF455BB8}" type="datetimeFigureOut">
              <a:rPr kumimoji="1" lang="zh-CN" altLang="en-US" smtClean="0"/>
              <a:t>2019/7/12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AF16850-F883-F747-8CE5-2A1DED6EE2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D63EDF9-0DD6-164D-B480-BB5E3A64EC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CC12D-4338-4C46-877D-F3B12860AC2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185889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EFAB456-D3F6-2843-BD76-A6F1F255EB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4D8AC35-90B1-7E48-8BA6-A7E87519A3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F366850-76F9-DF40-B1BD-B22A94F7DB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FF8DB-CD13-B140-B6B9-7CACDF455BB8}" type="datetimeFigureOut">
              <a:rPr kumimoji="1" lang="zh-CN" altLang="en-US" smtClean="0"/>
              <a:t>2019/7/12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182C637-677B-FC49-8FF1-1E40B62347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6A4DF68-B9BA-C547-8C6D-5E4542A121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CC12D-4338-4C46-877D-F3B12860AC2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018455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B74E934-9A80-A246-A4B7-6BCBDDE2258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71B2DA8-A5F1-454E-BD0A-7332B0E71A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A5AAA39-FF5E-5649-8C1D-4DB724531C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FF8DB-CD13-B140-B6B9-7CACDF455BB8}" type="datetimeFigureOut">
              <a:rPr kumimoji="1" lang="zh-CN" altLang="en-US" smtClean="0"/>
              <a:t>2019/7/12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7099A8C-DC2C-2A4B-9E87-4738679E6A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1BF69FF-33FE-D246-A659-AFD15822D8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CC12D-4338-4C46-877D-F3B12860AC2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025592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EAEF61C-927D-6E41-B80A-1754841DEF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B2DF57B-21C0-5D43-BB46-E52F32590BA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4853407-E28B-464E-AD63-3FEF6CD87A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FF8DB-CD13-B140-B6B9-7CACDF455BB8}" type="datetimeFigureOut">
              <a:rPr kumimoji="1" lang="zh-CN" altLang="en-US" smtClean="0"/>
              <a:t>2019/7/12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960D1DD-3E6A-E746-985C-1DB0E5251B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AC3BB82-4DF2-D94F-94B1-39FD44CE5F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CC12D-4338-4C46-877D-F3B12860AC2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44523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14E701-ED92-1C4D-918B-8F757A9E9C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2943855-9B99-584C-8AD2-8FEA9C55D2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99DBDDC-290B-DE4F-BEA3-4C4543E6EA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FF8DB-CD13-B140-B6B9-7CACDF455BB8}" type="datetimeFigureOut">
              <a:rPr kumimoji="1" lang="zh-CN" altLang="en-US" smtClean="0"/>
              <a:t>2019/7/12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B877890-183F-0E4C-BC01-2B49160A30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0A1C806-5B56-6C45-B013-FFD12FC55F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CC12D-4338-4C46-877D-F3B12860AC2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345352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1B211D-5B21-424F-82C6-06925AB505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64DE26A-7BC6-6D4A-95D5-5E65ED1618E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A01E9C4-E961-5340-ADF5-36A9C5E828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3058145-EA45-E349-A69E-2162F3424D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FF8DB-CD13-B140-B6B9-7CACDF455BB8}" type="datetimeFigureOut">
              <a:rPr kumimoji="1" lang="zh-CN" altLang="en-US" smtClean="0"/>
              <a:t>2019/7/12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2EBA4B7-6180-6440-BDC1-AAC96DD05C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000DBB2-B30E-BB42-B606-86BFCD5811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CC12D-4338-4C46-877D-F3B12860AC2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513948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1565EDD-415A-9141-A3BB-99C86325D1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66FF0A5-4736-8444-BB73-26E013824B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5BDBE89-7DE9-2D4B-84FC-B6ABFFCB6F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62E7422-3B05-D54A-B38B-0AA0007626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59908AA-532C-B14E-8CDA-CA490A4E6C9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1926006-6831-E745-B93C-E50AD90D5A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FF8DB-CD13-B140-B6B9-7CACDF455BB8}" type="datetimeFigureOut">
              <a:rPr kumimoji="1" lang="zh-CN" altLang="en-US" smtClean="0"/>
              <a:t>2019/7/12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CD6FD4E-02DD-C14E-9C67-006D769EFB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95373CC-3677-4843-A0BD-4DFA1413D3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CC12D-4338-4C46-877D-F3B12860AC2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753317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E1C0FE3-A354-494C-A7F6-33CF0FDF98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63E5488-A4D9-A741-A413-46D4934365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FF8DB-CD13-B140-B6B9-7CACDF455BB8}" type="datetimeFigureOut">
              <a:rPr kumimoji="1" lang="zh-CN" altLang="en-US" smtClean="0"/>
              <a:t>2019/7/12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2355F27-CDF2-3345-8C16-FC5AB6223C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3A17A84-175A-BF43-8A3D-0CE178E0B6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CC12D-4338-4C46-877D-F3B12860AC2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293155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AFB3E87-6A70-D74C-B580-FBDE5860B3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FF8DB-CD13-B140-B6B9-7CACDF455BB8}" type="datetimeFigureOut">
              <a:rPr kumimoji="1" lang="zh-CN" altLang="en-US" smtClean="0"/>
              <a:t>2019/7/12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2568CFD-9023-9B46-BAF8-B6C2DC11AA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1C0DC62-5563-B14E-ADC1-DDC07259EB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CC12D-4338-4C46-877D-F3B12860AC2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170505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6526E7-8542-8C42-9BF3-7B0CDE3B29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7A77669-1CC7-4D40-9C79-6727F7AD54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BBC7971-511B-6C49-B354-A4D5E2981A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AEC7665-1E83-234F-89AD-54768FEB52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FF8DB-CD13-B140-B6B9-7CACDF455BB8}" type="datetimeFigureOut">
              <a:rPr kumimoji="1" lang="zh-CN" altLang="en-US" smtClean="0"/>
              <a:t>2019/7/12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1C34DC6-A1D3-8744-BF7C-CDD2F784E6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C8BFFF4-EED8-F84E-83EF-B14284CBB4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CC12D-4338-4C46-877D-F3B12860AC2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387956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97498A5-D66F-414F-8EF7-913742A21A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60B0DBA-54BB-0C4A-BD6E-DCFF43A98E5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B0B11D4-2D13-2A46-9075-F8AF9115C7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8A54BC9-ECAF-214B-A0EA-BAAD9B2118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FF8DB-CD13-B140-B6B9-7CACDF455BB8}" type="datetimeFigureOut">
              <a:rPr kumimoji="1" lang="zh-CN" altLang="en-US" smtClean="0"/>
              <a:t>2019/7/12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B4C6B34-E61A-3A4A-8825-BE26BDE8C8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3439E79-D17A-014D-96BB-CFEE51ACC1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CC12D-4338-4C46-877D-F3B12860AC2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78819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BDC5698-DC1C-1340-A263-BDA36800A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9A2120F-9FC4-274D-AABB-CF34AD59C6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62DDA0C-7B09-CC4E-BE63-30258DC087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4FF8DB-CD13-B140-B6B9-7CACDF455BB8}" type="datetimeFigureOut">
              <a:rPr kumimoji="1" lang="zh-CN" altLang="en-US" smtClean="0"/>
              <a:t>2019/7/12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7E37A79-80DA-4249-9434-57B4177F0DE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7AF2907-D53E-4B43-9C1F-E5C964325A3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ACC12D-4338-4C46-877D-F3B12860AC2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22824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C35E5FC7-F4E1-A647-84E7-8108BAB91A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5229" y="2066975"/>
            <a:ext cx="4387850" cy="1831662"/>
          </a:xfrm>
          <a:prstGeom prst="rect">
            <a:avLst/>
          </a:prstGeom>
        </p:spPr>
      </p:pic>
      <p:sp>
        <p:nvSpPr>
          <p:cNvPr id="6" name="矩形标注 20">
            <a:extLst>
              <a:ext uri="{FF2B5EF4-FFF2-40B4-BE49-F238E27FC236}">
                <a16:creationId xmlns:a16="http://schemas.microsoft.com/office/drawing/2014/main" id="{F577EA45-005F-524A-B8A4-51906308DC96}"/>
              </a:ext>
            </a:extLst>
          </p:cNvPr>
          <p:cNvSpPr/>
          <p:nvPr/>
        </p:nvSpPr>
        <p:spPr>
          <a:xfrm rot="16200000">
            <a:off x="5121147" y="2760554"/>
            <a:ext cx="1831662" cy="444500"/>
          </a:xfrm>
          <a:prstGeom prst="wedgeRectCallout">
            <a:avLst>
              <a:gd name="adj1" fmla="val -20834"/>
              <a:gd name="adj2" fmla="val 36890"/>
            </a:avLst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FF5A831E-26EB-C046-BDC9-23739D1AAB13}"/>
              </a:ext>
            </a:extLst>
          </p:cNvPr>
          <p:cNvSpPr/>
          <p:nvPr/>
        </p:nvSpPr>
        <p:spPr>
          <a:xfrm>
            <a:off x="5672328" y="3898636"/>
            <a:ext cx="11738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u871</a:t>
            </a: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0C219951-C345-F948-8B78-F298DB47E40F}"/>
              </a:ext>
            </a:extLst>
          </p:cNvPr>
          <p:cNvSpPr/>
          <p:nvPr/>
        </p:nvSpPr>
        <p:spPr>
          <a:xfrm>
            <a:off x="2638095" y="4619995"/>
            <a:ext cx="1116198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servational analysis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oss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ies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recurrent missense variant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Leu871Phe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78625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2</TotalTime>
  <Words>17</Words>
  <Application>Microsoft Macintosh PowerPoint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o Lin</dc:creator>
  <cp:lastModifiedBy>Mao Lin</cp:lastModifiedBy>
  <cp:revision>16</cp:revision>
  <dcterms:created xsi:type="dcterms:W3CDTF">2019-04-28T06:24:41Z</dcterms:created>
  <dcterms:modified xsi:type="dcterms:W3CDTF">2019-07-12T04:18:21Z</dcterms:modified>
</cp:coreProperties>
</file>